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405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ike.minnick\Documents\PUBS\Bb%20EGF%20paper\Figures\S%20Figure%202%20data-%20HUVEC%20migration%20assay%2024Jul201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690137091667191E-2"/>
          <c:y val="3.7864640280496485E-2"/>
          <c:w val="0.90348754128199027"/>
          <c:h val="0.900175039260509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46:$C$5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067.0000000000016</c:v>
                  </c:pt>
                  <c:pt idx="2">
                    <c:v>440.00000000000085</c:v>
                  </c:pt>
                  <c:pt idx="3">
                    <c:v>604.99999999999909</c:v>
                  </c:pt>
                  <c:pt idx="4">
                    <c:v>1671.9999999999964</c:v>
                  </c:pt>
                  <c:pt idx="5">
                    <c:v>2189</c:v>
                  </c:pt>
                  <c:pt idx="6">
                    <c:v>704.00000000000182</c:v>
                  </c:pt>
                </c:numCache>
              </c:numRef>
            </c:plus>
            <c:minus>
              <c:numRef>
                <c:f>Sheet1!$C$46:$C$5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067.0000000000016</c:v>
                  </c:pt>
                  <c:pt idx="2">
                    <c:v>440.00000000000085</c:v>
                  </c:pt>
                  <c:pt idx="3">
                    <c:v>604.99999999999909</c:v>
                  </c:pt>
                  <c:pt idx="4">
                    <c:v>1671.9999999999964</c:v>
                  </c:pt>
                  <c:pt idx="5">
                    <c:v>2189</c:v>
                  </c:pt>
                  <c:pt idx="6">
                    <c:v>704.000000000001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46:$A$52</c:f>
              <c:strCache>
                <c:ptCount val="7"/>
                <c:pt idx="0">
                  <c:v>0%FCS</c:v>
                </c:pt>
                <c:pt idx="1">
                  <c:v>VEGF</c:v>
                </c:pt>
                <c:pt idx="2">
                  <c:v>PCB 1ug/ml</c:v>
                </c:pt>
                <c:pt idx="3">
                  <c:v>pBBR 1ug/ml</c:v>
                </c:pt>
                <c:pt idx="4">
                  <c:v>GroESL 1ug/ml</c:v>
                </c:pt>
                <c:pt idx="5">
                  <c:v>D1 1ug/ml</c:v>
                </c:pt>
                <c:pt idx="6">
                  <c:v>GroES(-) 1ug/ml</c:v>
                </c:pt>
              </c:strCache>
            </c:strRef>
          </c:cat>
          <c:val>
            <c:numRef>
              <c:f>Sheet1!$B$46:$B$52</c:f>
              <c:numCache>
                <c:formatCode>General</c:formatCode>
                <c:ptCount val="7"/>
                <c:pt idx="0">
                  <c:v>198</c:v>
                </c:pt>
                <c:pt idx="1">
                  <c:v>23573</c:v>
                </c:pt>
                <c:pt idx="2">
                  <c:v>14498</c:v>
                </c:pt>
                <c:pt idx="3">
                  <c:v>14905</c:v>
                </c:pt>
                <c:pt idx="4">
                  <c:v>26642</c:v>
                </c:pt>
                <c:pt idx="5">
                  <c:v>18535</c:v>
                </c:pt>
                <c:pt idx="6">
                  <c:v>221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71-4546-B303-78B309173D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7642744"/>
        <c:axId val="397643728"/>
      </c:barChart>
      <c:catAx>
        <c:axId val="3976427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97643728"/>
        <c:crosses val="autoZero"/>
        <c:auto val="1"/>
        <c:lblAlgn val="ctr"/>
        <c:lblOffset val="100"/>
        <c:noMultiLvlLbl val="0"/>
      </c:catAx>
      <c:valAx>
        <c:axId val="3976437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76427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8">
  <a:schemeClr val="accent5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364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713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24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734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72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093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62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251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283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213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210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0E7E4-2DB1-426F-AEED-02E0662FB7F1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07018-F18F-49DA-AFAB-615E71C8E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027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3351898" y="1582758"/>
          <a:ext cx="6401702" cy="36894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5204916" y="5288691"/>
            <a:ext cx="30401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Treatment or cell lysate used  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2063821" y="3242820"/>
            <a:ext cx="2206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. migrated HUVEC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226126" y="5042470"/>
            <a:ext cx="75552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    None               VEGF             JB584            LSS001           LSS100          LSS300            LSS500                                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226759" y="253554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517262" y="3118876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690577" y="318041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861804" y="209176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344226" y="170301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8995624" y="231562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3172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23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nick, Mike</dc:creator>
  <cp:lastModifiedBy>Minnick, Mike</cp:lastModifiedBy>
  <cp:revision>4</cp:revision>
  <dcterms:created xsi:type="dcterms:W3CDTF">2020-01-15T17:33:41Z</dcterms:created>
  <dcterms:modified xsi:type="dcterms:W3CDTF">2020-03-30T17:03:22Z</dcterms:modified>
</cp:coreProperties>
</file>